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9" r:id="rId2"/>
    <p:sldId id="277" r:id="rId3"/>
    <p:sldId id="269" r:id="rId4"/>
    <p:sldId id="278" r:id="rId5"/>
    <p:sldId id="27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 snapVertSplitter="1" vertBarState="minimized" horzBarState="maximized">
    <p:restoredLeft sz="15620"/>
    <p:restoredTop sz="92881" autoAdjust="0"/>
  </p:normalViewPr>
  <p:slideViewPr>
    <p:cSldViewPr>
      <p:cViewPr>
        <p:scale>
          <a:sx n="70" d="100"/>
          <a:sy n="70" d="100"/>
        </p:scale>
        <p:origin x="-2502" y="-4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342DC0-B8AC-4829-8AAD-8C123ECE4554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4FCB07-C2E5-4F49-BD84-929CA40930F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427793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4FCB07-C2E5-4F49-BD84-929CA40930F0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066800" y="1524000"/>
          <a:ext cx="6400800" cy="3581406"/>
        </p:xfrm>
        <a:graphic>
          <a:graphicData uri="http://schemas.openxmlformats.org/drawingml/2006/table">
            <a:tbl>
              <a:tblPr/>
              <a:tblGrid>
                <a:gridCol w="2067717"/>
                <a:gridCol w="4333083"/>
              </a:tblGrid>
              <a:tr h="38936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b="1" kern="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</a:t>
                      </a:r>
                      <a:endParaRPr lang="en-US" sz="1400" kern="100" dirty="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b="1" kern="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s</a:t>
                      </a:r>
                      <a:endParaRPr lang="en-US" sz="1400" kern="100" dirty="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1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ATTTATCAATACAATTGCG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1</a:t>
                      </a:r>
                      <a:endParaRPr lang="en-US" sz="1400" kern="100" dirty="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GAATTGGGACAACTCCAGTG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1-1(</a:t>
                      </a: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 5’ R)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TCGTAAAACGTTAGATAA 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ub 5’ F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ACACATGTAAAATACCTC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2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TCGCAAATGGCCAAATAAG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2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TTGTAGCCGTTGCTCTTTC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2-1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TATTCCTTTTCTAGTTTAAAATATAC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3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TTATGTGTGGGAGGGC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SG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3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TGACATATTGTGTTCATGATATATG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1"/>
                    </a:solidFill>
                  </a:tcPr>
                </a:tc>
              </a:tr>
              <a:tr h="31920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3-1</a:t>
                      </a:r>
                      <a:endParaRPr lang="en-US" sz="1400" kern="10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AATCTTCCTTATAAATATAGAATAATG </a:t>
                      </a:r>
                      <a:endParaRPr lang="en-US" sz="1400" kern="100" dirty="0">
                        <a:latin typeface="Times New Roman"/>
                        <a:ea typeface="SimSu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09600" y="838200"/>
            <a:ext cx="60198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able S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 Primers used in this study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57200" y="5486400"/>
            <a:ext cx="8229600" cy="954107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itchFamily="34" charset="0"/>
              </a:rPr>
              <a:t>Figure S1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ature gametocytes of the transgenic line 3D7</a:t>
            </a:r>
            <a:r>
              <a:rPr lang="en-US" sz="14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sz="1400" b="1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ubII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/GFP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graphs show strong GFP expression in both male an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emale gametocytes. Upper panel, GFP fluorescence. Lower panel: Bright field image showing a male gametocyte (left) with dispersed chromatin and a female gametocyte (right) with condensed chromatin.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5600" y="533400"/>
            <a:ext cx="2667000" cy="47893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Rectangle 20"/>
          <p:cNvSpPr/>
          <p:nvPr/>
        </p:nvSpPr>
        <p:spPr>
          <a:xfrm>
            <a:off x="304800" y="5867400"/>
            <a:ext cx="8610600" cy="523220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itchFamily="34" charset="0"/>
              </a:rPr>
              <a:t>Figure S2.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atter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owing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e gating signals and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uorescence intensity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2%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metocytemia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stag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 to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 gametocytes. 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838200" y="771524"/>
            <a:ext cx="7311093" cy="4943475"/>
            <a:chOff x="838200" y="771524"/>
            <a:chExt cx="7311093" cy="4943475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8200" y="771524"/>
              <a:ext cx="7311093" cy="4943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5110988" y="4252076"/>
              <a:ext cx="14542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uorescence intensit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/>
          <p:cNvSpPr txBox="1"/>
          <p:nvPr/>
        </p:nvSpPr>
        <p:spPr>
          <a:xfrm>
            <a:off x="4183309" y="1061172"/>
            <a:ext cx="312491" cy="310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57400" y="1371600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GFP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048375" y="1397587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JC-1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52425" y="1061199"/>
            <a:ext cx="312491" cy="310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 r="53324" b="2736"/>
          <a:stretch>
            <a:fillRect/>
          </a:stretch>
        </p:blipFill>
        <p:spPr bwMode="auto">
          <a:xfrm>
            <a:off x="685800" y="1600200"/>
            <a:ext cx="3276600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00600" y="1676400"/>
            <a:ext cx="3133725" cy="305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Rectangle 16"/>
          <p:cNvSpPr/>
          <p:nvPr/>
        </p:nvSpPr>
        <p:spPr>
          <a:xfrm>
            <a:off x="381000" y="5257800"/>
            <a:ext cx="8610600" cy="738664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itchFamily="34" charset="0"/>
              </a:rPr>
              <a:t>Figure S3. Comparative quantitation of GFP and JC-1 signal intensity after treatment with PMQ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areas under curves in the histogram show the fluorescence intensities (FI) of GFP (A) and JC-1 (B) of stage V gametocytes with or without PMQ treatment. PMQ treatment was done at 62.5 – 500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2762074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152400"/>
            <a:ext cx="8705850" cy="4848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Rectangle 5"/>
          <p:cNvSpPr/>
          <p:nvPr/>
        </p:nvSpPr>
        <p:spPr>
          <a:xfrm>
            <a:off x="314325" y="5334000"/>
            <a:ext cx="8534399" cy="954107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itchFamily="34" charset="0"/>
              </a:rPr>
              <a:t>Figure S4.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Drug respons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urves of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age I – V gametocytes to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hloroquin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CQ), dihydroartemisinin (DHA),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imaquin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PMQ) and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yronaridin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PND)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he graphs show the fluorescence intensity (FI) values of the gametocytes with the error bars representing the standard error of th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 from three biological replicates. 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40</TotalTime>
  <Words>246</Words>
  <Application>Microsoft Office PowerPoint</Application>
  <PresentationFormat>On-screen Show (4:3)</PresentationFormat>
  <Paragraphs>33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zl</dc:creator>
  <cp:lastModifiedBy>wzl</cp:lastModifiedBy>
  <cp:revision>335</cp:revision>
  <dcterms:created xsi:type="dcterms:W3CDTF">2006-08-16T00:00:00Z</dcterms:created>
  <dcterms:modified xsi:type="dcterms:W3CDTF">2014-03-28T14:48:09Z</dcterms:modified>
</cp:coreProperties>
</file>